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282147-F11C-444C-93B9-305A0D94E9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6D101387-9FDD-45FE-B366-718C5A9548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1C00045-E8FA-4E80-B37E-D3274D675D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AA95291-DD59-4F05-87DA-9D22BEA56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A26136F-EF60-4C4A-95CF-6BBE297B5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3994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059319-38ED-4E4C-B241-4B05F63C9F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C644443-B310-4ED0-93CF-9514A9DE2B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08A7C30-76C0-410C-8EB4-332FA7B1D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8D1318F-93B9-4C6E-832B-0612F8448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F001AF-ECEF-448C-A50B-272B6C0A4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5306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6084E0A-FDB8-4B1F-952C-9CFE799ECE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AD48BE6-633D-4ADD-AEBB-EEBA736D74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14999A2-FA07-44FA-90C7-CCB3F1AF4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138FA9-BCD0-4464-A04E-D241A419B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3795456-418F-4EBD-94F0-510019C14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4657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B4FFC12-693F-43C8-940A-9F2FF3241E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37C6367-89E7-4AD2-B7E1-7E25E6F536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03CE8FF-A9F8-4CFA-9734-3D86D6D94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F81C46F-7E93-4155-8742-FE31C701A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ECB4EE-5045-4688-A1E8-4B9B8907D3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8211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C476D1-3D27-4240-A061-D97D0399A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5E21954-8A2F-420E-A079-E37723482A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FCF8903-124F-4292-A23D-375E54D52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3FE46BA-D345-422B-8B75-7C659E113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BF9B464-124A-4F54-9A02-2AC0F7B95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5080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3BB433-9411-4165-A578-7FADA08DB3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E222308-EBAB-4953-9683-B1EBE714A5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5122C6D-FC35-4FC8-9986-D75C980755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97F9218-E231-4948-8BD7-781F3F5B7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0BA3984-A5FF-4823-943C-BD651E02C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2DFA519-253A-4230-A5DB-F9A12FD45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7478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98387B-872F-4EFE-AE3C-1391DBB1A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858731B-C87B-4D86-8026-DC50512F96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3EF45D8-9947-4687-AC1E-6F5502F540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4EC5721-77C5-47E8-844F-851EFE3084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1245E02-B036-4C4F-8CDC-030ABCEDE2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21AD98D-9483-4D26-9E21-F7B325869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9CDB69C-D8C4-4CAA-A439-B69EDB6E1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97C8DD4-2916-4712-ACD1-CB0501828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8928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FBE00F-731F-4139-AEED-A6D3591D3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26488E6-2935-48C1-86E7-FD518CBE0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D9985D7-976F-4703-8EB9-9F807D2CF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AC442BF-6A7B-4BBF-9D2B-8825F8A10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148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5C04FE3-BA36-47D5-B652-697FB7D0F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DA26E64-780B-487A-A709-246C2046C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39E761C2-F456-46BF-931A-F01BE691F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086620-AC45-47B0-8FF2-D83DD79900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5989577-3041-4FDD-93D0-CA021178BB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4865C2A-E229-46B6-87FE-3F2D23901B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7338EC6-2F3E-4E59-A2D8-99C8BF5CF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647C58F-7A85-4B8F-8464-E886EA786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CFA3D18-1362-46D7-A67E-509CB22AD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463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680442-D7C1-482A-A564-2045FEABA0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46D853C-7AEE-4D5C-896A-314FA39378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591C6D4-30F9-4275-AC63-3350C3196C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8EF8480-2A92-4C51-A563-5606F022B3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565083B-28CF-4576-A835-EFEC363CD8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8DF903A-BF47-4C87-B35C-F834DD452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6010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9BD56241-1A00-40F9-A7E3-663B4FE92C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78893A1-B9CB-4AA8-98A2-6D0D47BEC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BC49268-0126-49B0-A2F9-BF7F36F62F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5E99D-41E1-481B-A13B-E68931243E53}" type="datetimeFigureOut">
              <a:rPr lang="de-DE" smtClean="0"/>
              <a:t>28.04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39B7EBB-2AE0-4F23-AA0F-705D878F22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2FD5B5E-EF40-47F4-8970-8B888A93F4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A61901-56CD-47BD-B4B5-534E0418E09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0250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7954" y="473256"/>
            <a:ext cx="4995858" cy="2911628"/>
          </a:xfrm>
          <a:prstGeom prst="rect">
            <a:avLst/>
          </a:prstGeom>
        </p:spPr>
      </p:pic>
      <p:sp>
        <p:nvSpPr>
          <p:cNvPr id="4" name="Textplatzhalter 3"/>
          <p:cNvSpPr txBox="1">
            <a:spLocks/>
          </p:cNvSpPr>
          <p:nvPr/>
        </p:nvSpPr>
        <p:spPr>
          <a:xfrm>
            <a:off x="1535217" y="1472480"/>
            <a:ext cx="3349612" cy="7080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ct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de-DE" sz="1000" dirty="0">
                <a:solidFill>
                  <a:srgbClr val="0070C0"/>
                </a:solidFill>
              </a:rPr>
              <a:t>Median observation time:  76.3 months (6.4 years)</a:t>
            </a:r>
          </a:p>
          <a:p>
            <a:pPr algn="l"/>
            <a:r>
              <a:rPr lang="de-DE" sz="1000" dirty="0">
                <a:solidFill>
                  <a:srgbClr val="0070C0"/>
                </a:solidFill>
              </a:rPr>
              <a:t>5-year OS 98% (95% CI 96.6-99.4)</a:t>
            </a:r>
          </a:p>
          <a:p>
            <a:pPr algn="l"/>
            <a:r>
              <a:rPr lang="de-DE" sz="1000" dirty="0">
                <a:solidFill>
                  <a:srgbClr val="0070C0"/>
                </a:solidFill>
              </a:rPr>
              <a:t>10-year OS 96.2% (95% CI 93.6-98.9)</a:t>
            </a:r>
          </a:p>
        </p:txBody>
      </p:sp>
      <p:sp>
        <p:nvSpPr>
          <p:cNvPr id="7" name="Titel 1">
            <a:extLst>
              <a:ext uri="{FF2B5EF4-FFF2-40B4-BE49-F238E27FC236}">
                <a16:creationId xmlns:a16="http://schemas.microsoft.com/office/drawing/2014/main" id="{608261A8-2378-4C8C-8C86-5B09CF7FEE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078" y="136702"/>
            <a:ext cx="12163921" cy="365163"/>
          </a:xfrm>
        </p:spPr>
        <p:txBody>
          <a:bodyPr>
            <a:noAutofit/>
          </a:bodyPr>
          <a:lstStyle/>
          <a:p>
            <a:r>
              <a:rPr lang="de-DE" sz="1400" b="1" dirty="0" err="1"/>
              <a:t>Supplemental</a:t>
            </a:r>
            <a:r>
              <a:rPr lang="de-DE" sz="1400" b="1" dirty="0"/>
              <a:t> Figure</a:t>
            </a:r>
            <a:r>
              <a:rPr lang="de-DE" sz="1400" dirty="0"/>
              <a:t> 2: </a:t>
            </a:r>
            <a:r>
              <a:rPr lang="en-US" sz="1400" dirty="0">
                <a:effectLst/>
                <a:ea typeface="Calibri" panose="020F0502020204030204" pitchFamily="34" charset="0"/>
              </a:rPr>
              <a:t>Overall survival for all patients with early stages (A), for the comparison GP AB </a:t>
            </a:r>
            <a:r>
              <a:rPr lang="en-US" sz="1400" i="1" dirty="0">
                <a:effectLst/>
                <a:ea typeface="Calibri" panose="020F0502020204030204" pitchFamily="34" charset="0"/>
              </a:rPr>
              <a:t>vs</a:t>
            </a:r>
            <a:r>
              <a:rPr lang="en-US" sz="1400" dirty="0">
                <a:effectLst/>
                <a:ea typeface="Calibri" panose="020F0502020204030204" pitchFamily="34" charset="0"/>
              </a:rPr>
              <a:t> CDEF in early-stage patients (B), for the comparison GP ABC </a:t>
            </a:r>
            <a:r>
              <a:rPr lang="en-US" sz="1400" i="1" dirty="0">
                <a:effectLst/>
                <a:ea typeface="Calibri" panose="020F0502020204030204" pitchFamily="34" charset="0"/>
              </a:rPr>
              <a:t>vs</a:t>
            </a:r>
            <a:r>
              <a:rPr lang="en-US" sz="1400" dirty="0">
                <a:effectLst/>
                <a:ea typeface="Calibri" panose="020F0502020204030204" pitchFamily="34" charset="0"/>
              </a:rPr>
              <a:t> DEF in early-stage patients (C) and for the comparison GP ABCF </a:t>
            </a:r>
            <a:r>
              <a:rPr lang="en-US" sz="1400" i="1" dirty="0">
                <a:effectLst/>
                <a:ea typeface="Calibri" panose="020F0502020204030204" pitchFamily="34" charset="0"/>
              </a:rPr>
              <a:t>vs</a:t>
            </a:r>
            <a:r>
              <a:rPr lang="en-US" sz="1400" dirty="0">
                <a:effectLst/>
                <a:ea typeface="Calibri" panose="020F0502020204030204" pitchFamily="34" charset="0"/>
              </a:rPr>
              <a:t> DE in early-stage patients (D)</a:t>
            </a:r>
            <a:br>
              <a:rPr lang="de-DE" sz="1400" dirty="0">
                <a:effectLst/>
                <a:ea typeface="Calibri" panose="020F0502020204030204" pitchFamily="34" charset="0"/>
              </a:rPr>
            </a:br>
            <a:endParaRPr lang="en-US" sz="1400" dirty="0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550A6B1B-CBCB-4736-B9AF-5F86C488B3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1957" y="514492"/>
            <a:ext cx="4948990" cy="3007882"/>
          </a:xfrm>
          <a:prstGeom prst="rect">
            <a:avLst/>
          </a:prstGeom>
        </p:spPr>
      </p:pic>
      <p:sp>
        <p:nvSpPr>
          <p:cNvPr id="9" name="Textplatzhalter 3">
            <a:extLst>
              <a:ext uri="{FF2B5EF4-FFF2-40B4-BE49-F238E27FC236}">
                <a16:creationId xmlns:a16="http://schemas.microsoft.com/office/drawing/2014/main" id="{6E7AB6E4-6853-461B-A9C0-5DC7145E8169}"/>
              </a:ext>
            </a:extLst>
          </p:cNvPr>
          <p:cNvSpPr txBox="1">
            <a:spLocks/>
          </p:cNvSpPr>
          <p:nvPr/>
        </p:nvSpPr>
        <p:spPr>
          <a:xfrm>
            <a:off x="7342695" y="1402562"/>
            <a:ext cx="3237087" cy="920865"/>
          </a:xfrm>
          <a:prstGeom prst="rect">
            <a:avLst/>
          </a:prstGeom>
        </p:spPr>
        <p:txBody>
          <a:bodyPr vert="horz" lIns="36000" tIns="0" rIns="0" bIns="0" rtlCol="0">
            <a:noAutofit/>
          </a:bodyPr>
          <a:lstStyle>
            <a:lvl1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1pPr>
            <a:lvl2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2pPr>
            <a:lvl3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3pPr>
            <a:lvl4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4pPr>
            <a:lvl5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5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5-year OS 98% (95% CI 96.4-99.6)</a:t>
            </a:r>
          </a:p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10-year OS 95.7% (95% CI 92.3-99)</a:t>
            </a:r>
            <a:endParaRPr lang="en-US" sz="1000" dirty="0">
              <a:solidFill>
                <a:schemeClr val="accent2"/>
              </a:solidFill>
            </a:endParaRP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5-year OS 98% (95% CI 95.1-100)</a:t>
            </a: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10-year OS 98% (95% CI 95.1-100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None/>
            </a:pPr>
            <a:r>
              <a:rPr lang="de-DE" sz="1000" dirty="0">
                <a:solidFill>
                  <a:schemeClr val="tx1"/>
                </a:solidFill>
              </a:rPr>
              <a:t>HR = 0.7 (95% CI 0.2-3.3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Font typeface="Arial"/>
              <a:buNone/>
            </a:pPr>
            <a:endParaRPr lang="de-DE" sz="1000" dirty="0">
              <a:solidFill>
                <a:srgbClr val="0070C0"/>
              </a:solidFill>
            </a:endParaRP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2FC27BFC-24A1-4F1B-9895-A4E764FEEE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807" y="3645033"/>
            <a:ext cx="5052005" cy="3229005"/>
          </a:xfrm>
          <a:prstGeom prst="rect">
            <a:avLst/>
          </a:prstGeom>
        </p:spPr>
      </p:pic>
      <p:sp>
        <p:nvSpPr>
          <p:cNvPr id="11" name="Textplatzhalter 3">
            <a:extLst>
              <a:ext uri="{FF2B5EF4-FFF2-40B4-BE49-F238E27FC236}">
                <a16:creationId xmlns:a16="http://schemas.microsoft.com/office/drawing/2014/main" id="{E6D1510F-4A14-495D-8EEE-AF4069CEA7CE}"/>
              </a:ext>
            </a:extLst>
          </p:cNvPr>
          <p:cNvSpPr txBox="1">
            <a:spLocks/>
          </p:cNvSpPr>
          <p:nvPr/>
        </p:nvSpPr>
        <p:spPr>
          <a:xfrm>
            <a:off x="1481830" y="4613057"/>
            <a:ext cx="2657042" cy="1081892"/>
          </a:xfrm>
          <a:prstGeom prst="rect">
            <a:avLst/>
          </a:prstGeom>
        </p:spPr>
        <p:txBody>
          <a:bodyPr vert="horz" lIns="36000" tIns="0" rIns="0" bIns="0" rtlCol="0">
            <a:noAutofit/>
          </a:bodyPr>
          <a:lstStyle>
            <a:lvl1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1pPr>
            <a:lvl2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2pPr>
            <a:lvl3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3pPr>
            <a:lvl4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4pPr>
            <a:lvl5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5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5-year OS 97.9% (95% CI 96.4-99.5)</a:t>
            </a:r>
          </a:p>
          <a:p>
            <a:pPr marL="0" indent="0">
              <a:buNone/>
            </a:pPr>
            <a:r>
              <a:rPr lang="de-DE" sz="1000" dirty="0">
                <a:solidFill>
                  <a:srgbClr val="0070C0"/>
                </a:solidFill>
              </a:rPr>
              <a:t>10-year OS </a:t>
            </a:r>
            <a:r>
              <a:rPr lang="en-US" sz="1000" dirty="0">
                <a:solidFill>
                  <a:srgbClr val="0070C0"/>
                </a:solidFill>
              </a:rPr>
              <a:t>95.9% (95% CI 92.9-98.9)</a:t>
            </a:r>
            <a:endParaRPr lang="en-US" sz="1000" dirty="0">
              <a:solidFill>
                <a:schemeClr val="accent2"/>
              </a:solidFill>
            </a:endParaRP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5-year OS 98.3% (95% CI 94.9-100)</a:t>
            </a: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10-year OS 98.3% (95% CI 94.9-100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None/>
            </a:pPr>
            <a:r>
              <a:rPr lang="de-DE" sz="1000" dirty="0">
                <a:solidFill>
                  <a:schemeClr val="tx1"/>
                </a:solidFill>
              </a:rPr>
              <a:t>HR = 0.7 (95% CI 0.1-5.2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Font typeface="Arial"/>
              <a:buNone/>
            </a:pPr>
            <a:endParaRPr lang="de-DE" sz="1000" dirty="0">
              <a:solidFill>
                <a:srgbClr val="0070C0"/>
              </a:solidFill>
            </a:endParaRP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AEF8EB36-77DF-41CD-AF15-F76C883BB1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1958" y="3653054"/>
            <a:ext cx="4948990" cy="3220984"/>
          </a:xfrm>
          <a:prstGeom prst="rect">
            <a:avLst/>
          </a:prstGeom>
        </p:spPr>
      </p:pic>
      <p:sp>
        <p:nvSpPr>
          <p:cNvPr id="13" name="Textplatzhalter 3">
            <a:extLst>
              <a:ext uri="{FF2B5EF4-FFF2-40B4-BE49-F238E27FC236}">
                <a16:creationId xmlns:a16="http://schemas.microsoft.com/office/drawing/2014/main" id="{23ECAD1F-C963-4906-98B0-E3E01939E9BF}"/>
              </a:ext>
            </a:extLst>
          </p:cNvPr>
          <p:cNvSpPr txBox="1">
            <a:spLocks/>
          </p:cNvSpPr>
          <p:nvPr/>
        </p:nvSpPr>
        <p:spPr>
          <a:xfrm>
            <a:off x="7341498" y="4615588"/>
            <a:ext cx="2444181" cy="666792"/>
          </a:xfrm>
          <a:prstGeom prst="rect">
            <a:avLst/>
          </a:prstGeom>
        </p:spPr>
        <p:txBody>
          <a:bodyPr vert="horz" lIns="36000" tIns="0" rIns="0" bIns="0" rtlCol="0">
            <a:noAutofit/>
          </a:bodyPr>
          <a:lstStyle>
            <a:lvl1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1pPr>
            <a:lvl2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2pPr>
            <a:lvl3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3pPr>
            <a:lvl4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4pPr>
            <a:lvl5pPr marL="89998" indent="-89998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900" b="0" i="0" kern="1200">
                <a:solidFill>
                  <a:srgbClr val="888B8C"/>
                </a:solidFill>
                <a:latin typeface="+mn-lt"/>
                <a:ea typeface="+mn-ea"/>
                <a:cs typeface="+mn-cs"/>
              </a:defRPr>
            </a:lvl5pPr>
            <a:lvl6pPr marL="2514537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726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8915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103" indent="-228594" algn="l" defTabSz="457189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5-year OS 98% (95% CI 96.5-99.5)</a:t>
            </a:r>
          </a:p>
          <a:p>
            <a:pPr marL="0" indent="0">
              <a:buFont typeface="Arial"/>
              <a:buNone/>
            </a:pPr>
            <a:r>
              <a:rPr lang="de-DE" sz="1000" dirty="0">
                <a:solidFill>
                  <a:srgbClr val="0070C0"/>
                </a:solidFill>
              </a:rPr>
              <a:t>10-year OS 96% (95% CI 93.1-99)</a:t>
            </a:r>
            <a:endParaRPr lang="en-US" sz="1000" dirty="0">
              <a:solidFill>
                <a:schemeClr val="accent2"/>
              </a:solidFill>
            </a:endParaRP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5-year OS 97.9% (95% CI 93.7-100)</a:t>
            </a:r>
          </a:p>
          <a:p>
            <a:pPr marL="0" indent="0">
              <a:buNone/>
            </a:pPr>
            <a:r>
              <a:rPr lang="en-US" sz="1000" dirty="0">
                <a:solidFill>
                  <a:schemeClr val="accent2"/>
                </a:solidFill>
              </a:rPr>
              <a:t>10-year OS 97.9% (95% CI 93.7-100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None/>
            </a:pPr>
            <a:r>
              <a:rPr lang="de-DE" sz="1000" dirty="0">
                <a:solidFill>
                  <a:schemeClr val="tx1"/>
                </a:solidFill>
              </a:rPr>
              <a:t>HR = 0.9 (95% CI 0.1-6.7)</a:t>
            </a:r>
            <a:endParaRPr lang="de-DE" sz="1000" dirty="0">
              <a:solidFill>
                <a:srgbClr val="0070C0"/>
              </a:solidFill>
            </a:endParaRPr>
          </a:p>
          <a:p>
            <a:pPr marL="0" indent="0">
              <a:buFont typeface="Arial"/>
              <a:buNone/>
            </a:pPr>
            <a:endParaRPr lang="de-DE" sz="1000" dirty="0">
              <a:solidFill>
                <a:srgbClr val="0070C0"/>
              </a:solidFill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0771B118-8394-45D6-B4C0-A37EA33A0CF0}"/>
              </a:ext>
            </a:extLst>
          </p:cNvPr>
          <p:cNvSpPr txBox="1"/>
          <p:nvPr/>
        </p:nvSpPr>
        <p:spPr>
          <a:xfrm>
            <a:off x="874293" y="721894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4216F9C-F6DB-42B7-9B33-9D8C82B36D7D}"/>
              </a:ext>
            </a:extLst>
          </p:cNvPr>
          <p:cNvSpPr txBox="1"/>
          <p:nvPr/>
        </p:nvSpPr>
        <p:spPr>
          <a:xfrm>
            <a:off x="6585301" y="721894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DB355203-13A8-4E83-BDD5-C8D3FD77BB11}"/>
              </a:ext>
            </a:extLst>
          </p:cNvPr>
          <p:cNvSpPr txBox="1"/>
          <p:nvPr/>
        </p:nvSpPr>
        <p:spPr>
          <a:xfrm>
            <a:off x="874293" y="3882193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788D487D-7AD5-4BF1-B5F6-A929A273531B}"/>
              </a:ext>
            </a:extLst>
          </p:cNvPr>
          <p:cNvSpPr txBox="1"/>
          <p:nvPr/>
        </p:nvSpPr>
        <p:spPr>
          <a:xfrm>
            <a:off x="6585307" y="3898235"/>
            <a:ext cx="46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475322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7</Words>
  <Application>Microsoft Office PowerPoint</Application>
  <PresentationFormat>Breitbild</PresentationFormat>
  <Paragraphs>2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Supplemental Figure 2: Overall survival for all patients with early stages (A), for the comparison GP AB vs CDEF in early-stage patients (B), for the comparison GP ABC vs DEF in early-stage patients (C) and for the comparison GP ABCF vs DE in early-stage patients (D)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2: Overall survival for all patients with early stages (A), for the comparison GP AB vs CDEF in early-stage patients (B), for the comparison GP ABC vs DEF in early-stage patients (C) and for the comparison GP ABCF vs DE in early-stage patients (D) </dc:title>
  <dc:creator>Dennis Eichenauer</dc:creator>
  <cp:lastModifiedBy>Dennis Eichenauer</cp:lastModifiedBy>
  <cp:revision>2</cp:revision>
  <dcterms:created xsi:type="dcterms:W3CDTF">2025-04-28T06:52:57Z</dcterms:created>
  <dcterms:modified xsi:type="dcterms:W3CDTF">2025-04-28T07:25:45Z</dcterms:modified>
</cp:coreProperties>
</file>